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96" autoAdjust="0"/>
    <p:restoredTop sz="94660"/>
  </p:normalViewPr>
  <p:slideViewPr>
    <p:cSldViewPr snapToGrid="0">
      <p:cViewPr varScale="1">
        <p:scale>
          <a:sx n="74" d="100"/>
          <a:sy n="74" d="100"/>
        </p:scale>
        <p:origin x="84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5090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9164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0610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416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7840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0962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160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0848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2282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0466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6679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8F41B-C4DD-4F1E-864D-302A488E1032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C9E94D-CE05-4DEA-A37C-351A9EFCB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464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E382A652-4E83-CFDA-FBCF-DD96290666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7803"/>
            <a:ext cx="6759720" cy="4693594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F92DC1FF-A2FF-0693-C6B7-5D7F074ED871}"/>
              </a:ext>
            </a:extLst>
          </p:cNvPr>
          <p:cNvSpPr txBox="1"/>
          <p:nvPr/>
        </p:nvSpPr>
        <p:spPr>
          <a:xfrm>
            <a:off x="193184" y="5499279"/>
            <a:ext cx="66648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1. Verification of transcriptome differential genes of the female moths of </a:t>
            </a:r>
            <a:r>
              <a:rPr lang="en-US" altLang="zh-CN" sz="18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 suppressali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treated with α-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edaren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for 12 hours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Note: “NS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＞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5; “*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＜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5; “**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＜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1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（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-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est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）</a:t>
            </a:r>
          </a:p>
        </p:txBody>
      </p:sp>
    </p:spTree>
    <p:extLst>
      <p:ext uri="{BB962C8B-B14F-4D97-AF65-F5344CB8AC3E}">
        <p14:creationId xmlns:p14="http://schemas.microsoft.com/office/powerpoint/2010/main" val="29599145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92DC1FF-A2FF-0693-C6B7-5D7F074ED871}"/>
              </a:ext>
            </a:extLst>
          </p:cNvPr>
          <p:cNvSpPr txBox="1"/>
          <p:nvPr/>
        </p:nvSpPr>
        <p:spPr>
          <a:xfrm>
            <a:off x="193184" y="5499279"/>
            <a:ext cx="66648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2. Verification of transcriptome differential genes of the female moths of </a:t>
            </a:r>
            <a:r>
              <a:rPr lang="en-US" altLang="zh-CN" sz="18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 suppressali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treated with α-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edaren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for 36 hours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Note: “NS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＞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5; “*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＜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5; “**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＜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1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（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-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est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）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210B34A0-86E6-CB6C-D26F-1AB07D2F046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2853"/>
          <a:stretch>
            <a:fillRect/>
          </a:stretch>
        </p:blipFill>
        <p:spPr>
          <a:xfrm>
            <a:off x="133261" y="359606"/>
            <a:ext cx="6724739" cy="452148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849632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143F904-15C8-E09E-6989-EC830D6801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612" y="584660"/>
            <a:ext cx="6417227" cy="4425221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F48A2CE-12C9-0A24-FCB6-CBE93C988941}"/>
              </a:ext>
            </a:extLst>
          </p:cNvPr>
          <p:cNvSpPr txBox="1"/>
          <p:nvPr/>
        </p:nvSpPr>
        <p:spPr>
          <a:xfrm>
            <a:off x="193184" y="5499279"/>
            <a:ext cx="66648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3. Verification of transcriptome differential genes of the female moths of </a:t>
            </a:r>
            <a:r>
              <a:rPr lang="en-US" altLang="zh-CN" sz="18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 suppressali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treated with 2-heptanol for 12 hours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Note: “NS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＞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5; “*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＜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5; “**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＜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1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（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-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est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）</a:t>
            </a:r>
          </a:p>
        </p:txBody>
      </p:sp>
    </p:spTree>
    <p:extLst>
      <p:ext uri="{BB962C8B-B14F-4D97-AF65-F5344CB8AC3E}">
        <p14:creationId xmlns:p14="http://schemas.microsoft.com/office/powerpoint/2010/main" val="41332820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9F48A2CE-12C9-0A24-FCB6-CBE93C988941}"/>
              </a:ext>
            </a:extLst>
          </p:cNvPr>
          <p:cNvSpPr txBox="1"/>
          <p:nvPr/>
        </p:nvSpPr>
        <p:spPr>
          <a:xfrm>
            <a:off x="193184" y="5499279"/>
            <a:ext cx="66648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4. Verification of transcriptome differential genes of the female moths of </a:t>
            </a:r>
            <a:r>
              <a:rPr lang="en-US" altLang="zh-CN" sz="18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 suppressali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treated with 2-heptanol for 36 hours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Note: “NS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＞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5; “*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＜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5; “**” mean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＜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0.01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（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-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est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）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289C76BE-C63A-E208-E79C-D9B6E11E93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53" y="1756759"/>
            <a:ext cx="6837747" cy="31629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15925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1</TotalTime>
  <Words>184</Words>
  <Application>Microsoft Office PowerPoint</Application>
  <PresentationFormat>A4 纸张(210x297 毫米)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aowei Yang</dc:creator>
  <cp:lastModifiedBy>Xiaowei Yang</cp:lastModifiedBy>
  <cp:revision>1</cp:revision>
  <dcterms:created xsi:type="dcterms:W3CDTF">2025-06-16T11:02:18Z</dcterms:created>
  <dcterms:modified xsi:type="dcterms:W3CDTF">2025-06-17T10:43:19Z</dcterms:modified>
</cp:coreProperties>
</file>